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12192000" cy="10799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24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397" autoAdjust="0"/>
    <p:restoredTop sz="94660"/>
  </p:normalViewPr>
  <p:slideViewPr>
    <p:cSldViewPr snapToGrid="0" showGuides="1">
      <p:cViewPr>
        <p:scale>
          <a:sx n="118" d="100"/>
          <a:sy n="118" d="100"/>
        </p:scale>
        <p:origin x="-792" y="-2160"/>
      </p:cViewPr>
      <p:guideLst>
        <p:guide orient="horz" pos="3424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epal, Madhav" userId="8502bd4e-61e8-443b-b41a-3cbbe3f49576" providerId="ADAL" clId="{121BD817-4FEA-43C3-B4A4-9BE6A22D0A50}"/>
    <pc:docChg chg="modSld">
      <pc:chgData name="Nepal, Madhav" userId="8502bd4e-61e8-443b-b41a-3cbbe3f49576" providerId="ADAL" clId="{121BD817-4FEA-43C3-B4A4-9BE6A22D0A50}" dt="2020-04-18T14:23:58.661" v="1" actId="1076"/>
      <pc:docMkLst>
        <pc:docMk/>
      </pc:docMkLst>
      <pc:sldChg chg="modSp mod">
        <pc:chgData name="Nepal, Madhav" userId="8502bd4e-61e8-443b-b41a-3cbbe3f49576" providerId="ADAL" clId="{121BD817-4FEA-43C3-B4A4-9BE6A22D0A50}" dt="2020-04-18T14:23:58.661" v="1" actId="1076"/>
        <pc:sldMkLst>
          <pc:docMk/>
          <pc:sldMk cId="755524430" sldId="259"/>
        </pc:sldMkLst>
        <pc:spChg chg="mod">
          <ac:chgData name="Nepal, Madhav" userId="8502bd4e-61e8-443b-b41a-3cbbe3f49576" providerId="ADAL" clId="{121BD817-4FEA-43C3-B4A4-9BE6A22D0A50}" dt="2020-04-18T14:23:58.661" v="1" actId="1076"/>
          <ac:spMkLst>
            <pc:docMk/>
            <pc:sldMk cId="755524430" sldId="259"/>
            <ac:spMk id="118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767462"/>
            <a:ext cx="10363200" cy="375991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5672376"/>
            <a:ext cx="9144000" cy="2607442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49B33-5ECF-4383-B6C2-F8FBC33B78AB}" type="datetimeFigureOut">
              <a:rPr lang="el-GR" smtClean="0"/>
              <a:t>18/4/2020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1EE10-7467-4C8D-97D4-C2C4993A94E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8534860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49B33-5ECF-4383-B6C2-F8FBC33B78AB}" type="datetimeFigureOut">
              <a:rPr lang="el-GR" smtClean="0"/>
              <a:t>18/4/2020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1EE10-7467-4C8D-97D4-C2C4993A94E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0226521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574987"/>
            <a:ext cx="2628900" cy="9152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574987"/>
            <a:ext cx="7734300" cy="9152300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49B33-5ECF-4383-B6C2-F8FBC33B78AB}" type="datetimeFigureOut">
              <a:rPr lang="el-GR" smtClean="0"/>
              <a:t>18/4/2020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1EE10-7467-4C8D-97D4-C2C4993A94E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4085498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49B33-5ECF-4383-B6C2-F8FBC33B78AB}" type="datetimeFigureOut">
              <a:rPr lang="el-GR" smtClean="0"/>
              <a:t>18/4/2020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1EE10-7467-4C8D-97D4-C2C4993A94E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687391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692444"/>
            <a:ext cx="10515600" cy="4492401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7227345"/>
            <a:ext cx="10515600" cy="2362447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49B33-5ECF-4383-B6C2-F8FBC33B78AB}" type="datetimeFigureOut">
              <a:rPr lang="el-GR" smtClean="0"/>
              <a:t>18/4/2020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1EE10-7467-4C8D-97D4-C2C4993A94E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170344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874937"/>
            <a:ext cx="5181600" cy="685235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874937"/>
            <a:ext cx="5181600" cy="685235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49B33-5ECF-4383-B6C2-F8FBC33B78AB}" type="datetimeFigureOut">
              <a:rPr lang="el-GR" smtClean="0"/>
              <a:t>18/4/2020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1EE10-7467-4C8D-97D4-C2C4993A94E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3243672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74990"/>
            <a:ext cx="10515600" cy="208745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647443"/>
            <a:ext cx="5157787" cy="129747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944914"/>
            <a:ext cx="5157787" cy="580237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647443"/>
            <a:ext cx="5183188" cy="129747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944914"/>
            <a:ext cx="5183188" cy="580237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49B33-5ECF-4383-B6C2-F8FBC33B78AB}" type="datetimeFigureOut">
              <a:rPr lang="el-GR" smtClean="0"/>
              <a:t>18/4/2020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1EE10-7467-4C8D-97D4-C2C4993A94E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048198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49B33-5ECF-4383-B6C2-F8FBC33B78AB}" type="datetimeFigureOut">
              <a:rPr lang="el-GR" smtClean="0"/>
              <a:t>18/4/2020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1EE10-7467-4C8D-97D4-C2C4993A94E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9189951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49B33-5ECF-4383-B6C2-F8FBC33B78AB}" type="datetimeFigureOut">
              <a:rPr lang="el-GR" smtClean="0"/>
              <a:t>18/4/2020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1EE10-7467-4C8D-97D4-C2C4993A94E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863395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19984"/>
            <a:ext cx="3932237" cy="2519945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554968"/>
            <a:ext cx="6172200" cy="7674832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239929"/>
            <a:ext cx="3932237" cy="6002369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49B33-5ECF-4383-B6C2-F8FBC33B78AB}" type="datetimeFigureOut">
              <a:rPr lang="el-GR" smtClean="0"/>
              <a:t>18/4/2020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1EE10-7467-4C8D-97D4-C2C4993A94E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884369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19984"/>
            <a:ext cx="3932237" cy="2519945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554968"/>
            <a:ext cx="6172200" cy="7674832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239929"/>
            <a:ext cx="3932237" cy="6002369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49B33-5ECF-4383-B6C2-F8FBC33B78AB}" type="datetimeFigureOut">
              <a:rPr lang="el-GR" smtClean="0"/>
              <a:t>18/4/2020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1EE10-7467-4C8D-97D4-C2C4993A94E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37379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574990"/>
            <a:ext cx="10515600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874937"/>
            <a:ext cx="10515600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0009783"/>
            <a:ext cx="274320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549B33-5ECF-4383-B6C2-F8FBC33B78AB}" type="datetimeFigureOut">
              <a:rPr lang="el-GR" smtClean="0"/>
              <a:t>18/4/2020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0009783"/>
            <a:ext cx="411480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0009783"/>
            <a:ext cx="2743200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D1EE10-7467-4C8D-97D4-C2C4993A94EF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6826386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2"/>
          <a:srcRect r="20220" b="8928"/>
          <a:stretch/>
        </p:blipFill>
        <p:spPr>
          <a:xfrm>
            <a:off x="4493871" y="2040113"/>
            <a:ext cx="7532204" cy="4471079"/>
          </a:xfrm>
          <a:prstGeom prst="rect">
            <a:avLst/>
          </a:prstGeom>
        </p:spPr>
      </p:pic>
      <p:grpSp>
        <p:nvGrpSpPr>
          <p:cNvPr id="38" name="Group 37"/>
          <p:cNvGrpSpPr/>
          <p:nvPr/>
        </p:nvGrpSpPr>
        <p:grpSpPr>
          <a:xfrm>
            <a:off x="1199288" y="711326"/>
            <a:ext cx="10058400" cy="1263290"/>
            <a:chOff x="707639" y="104437"/>
            <a:chExt cx="10058400" cy="1263290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7639" y="259783"/>
              <a:ext cx="10058400" cy="1107944"/>
            </a:xfrm>
            <a:prstGeom prst="rect">
              <a:avLst/>
            </a:prstGeom>
          </p:spPr>
        </p:pic>
        <p:sp>
          <p:nvSpPr>
            <p:cNvPr id="7" name="Down Arrow 6"/>
            <p:cNvSpPr/>
            <p:nvPr/>
          </p:nvSpPr>
          <p:spPr>
            <a:xfrm>
              <a:off x="8970576" y="104437"/>
              <a:ext cx="45719" cy="155345"/>
            </a:xfrm>
            <a:prstGeom prst="down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  <p:sp>
          <p:nvSpPr>
            <p:cNvPr id="8" name="Down Arrow 7"/>
            <p:cNvSpPr/>
            <p:nvPr/>
          </p:nvSpPr>
          <p:spPr>
            <a:xfrm flipV="1">
              <a:off x="10332651" y="813755"/>
              <a:ext cx="45719" cy="155345"/>
            </a:xfrm>
            <a:prstGeom prst="downArrow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l-GR"/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-164978" y="2239922"/>
            <a:ext cx="5048503" cy="3273947"/>
            <a:chOff x="1143000" y="1598728"/>
            <a:chExt cx="5048503" cy="2976315"/>
          </a:xfrm>
        </p:grpSpPr>
        <p:cxnSp>
          <p:nvCxnSpPr>
            <p:cNvPr id="3" name="Straight Arrow Connector 2"/>
            <p:cNvCxnSpPr/>
            <p:nvPr/>
          </p:nvCxnSpPr>
          <p:spPr>
            <a:xfrm>
              <a:off x="3360934" y="2456979"/>
              <a:ext cx="458060" cy="0"/>
            </a:xfrm>
            <a:prstGeom prst="straightConnector1">
              <a:avLst/>
            </a:prstGeom>
            <a:ln w="28575">
              <a:solidFill>
                <a:schemeClr val="bg2">
                  <a:lumMod val="1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/>
            <p:cNvCxnSpPr/>
            <p:nvPr/>
          </p:nvCxnSpPr>
          <p:spPr>
            <a:xfrm>
              <a:off x="3360934" y="2606778"/>
              <a:ext cx="458060" cy="0"/>
            </a:xfrm>
            <a:prstGeom prst="straightConnector1">
              <a:avLst/>
            </a:prstGeom>
            <a:ln w="28575">
              <a:solidFill>
                <a:schemeClr val="bg2">
                  <a:lumMod val="1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Arrow Connector 16"/>
            <p:cNvCxnSpPr/>
            <p:nvPr/>
          </p:nvCxnSpPr>
          <p:spPr>
            <a:xfrm>
              <a:off x="3372847" y="2822826"/>
              <a:ext cx="458060" cy="0"/>
            </a:xfrm>
            <a:prstGeom prst="straightConnector1">
              <a:avLst/>
            </a:prstGeom>
            <a:ln w="28575">
              <a:solidFill>
                <a:schemeClr val="bg2">
                  <a:lumMod val="1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Arrow Connector 17"/>
            <p:cNvCxnSpPr/>
            <p:nvPr/>
          </p:nvCxnSpPr>
          <p:spPr>
            <a:xfrm>
              <a:off x="3372847" y="2972625"/>
              <a:ext cx="458060" cy="0"/>
            </a:xfrm>
            <a:prstGeom prst="straightConnector1">
              <a:avLst/>
            </a:prstGeom>
            <a:ln w="28575">
              <a:solidFill>
                <a:schemeClr val="bg2">
                  <a:lumMod val="1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1933169" y="2612579"/>
              <a:ext cx="141824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1938501" y="2810431"/>
              <a:ext cx="141824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2180694" y="2014824"/>
              <a:ext cx="1342571" cy="2560219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 rot="18900000">
              <a:off x="2281751" y="1598728"/>
              <a:ext cx="68297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100 </a:t>
              </a:r>
              <a:r>
                <a:rPr lang="en-US" sz="1000" dirty="0" err="1"/>
                <a:t>bp</a:t>
              </a:r>
              <a:r>
                <a:rPr lang="en-US" sz="1000" dirty="0"/>
                <a:t> ladder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 rot="18900000">
              <a:off x="2853256" y="1675673"/>
              <a:ext cx="6829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PCR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151680" y="2472219"/>
              <a:ext cx="102660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>
                <a:defRPr/>
              </a:pPr>
              <a:r>
                <a:rPr lang="en-US" sz="1000" dirty="0">
                  <a:cs typeface="Calibri" panose="020F0502020204030204" pitchFamily="34" charset="0"/>
                </a:rPr>
                <a:t>1100 </a:t>
              </a:r>
              <a:r>
                <a:rPr lang="en-US" sz="1000" dirty="0" err="1">
                  <a:cs typeface="Calibri" panose="020F0502020204030204" pitchFamily="34" charset="0"/>
                </a:rPr>
                <a:t>bp</a:t>
              </a:r>
              <a:endParaRPr lang="en-US" sz="1000" dirty="0">
                <a:cs typeface="Calibri" panose="020F050202020403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143000" y="2672766"/>
              <a:ext cx="102660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>
                <a:defRPr/>
              </a:pPr>
              <a:r>
                <a:rPr lang="en-US" sz="1000" dirty="0">
                  <a:cs typeface="Calibri" panose="020F0502020204030204" pitchFamily="34" charset="0"/>
                </a:rPr>
                <a:t> 1000 </a:t>
              </a:r>
              <a:r>
                <a:rPr lang="en-US" sz="1000" dirty="0" err="1">
                  <a:cs typeface="Calibri" panose="020F0502020204030204" pitchFamily="34" charset="0"/>
                </a:rPr>
                <a:t>bp</a:t>
              </a:r>
              <a:endParaRPr lang="en-US" sz="1000" dirty="0">
                <a:cs typeface="Calibri" panose="020F050202020403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264965" y="2349257"/>
              <a:ext cx="29265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>
                <a:defRPr/>
              </a:pPr>
              <a:r>
                <a:rPr lang="en-US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SV2 (4</a:t>
              </a:r>
              <a:r>
                <a:rPr lang="en-US" sz="1000" baseline="30000" dirty="0">
                  <a:latin typeface="Calibri" panose="020F0502020204030204" pitchFamily="34" charset="0"/>
                  <a:cs typeface="Calibri" panose="020F0502020204030204" pitchFamily="34" charset="0"/>
                </a:rPr>
                <a:t>th</a:t>
              </a:r>
              <a:r>
                <a:rPr lang="en-US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 &amp; 5</a:t>
              </a:r>
              <a:r>
                <a:rPr lang="en-US" sz="1000" baseline="30000" dirty="0">
                  <a:latin typeface="Calibri" panose="020F0502020204030204" pitchFamily="34" charset="0"/>
                  <a:cs typeface="Calibri" panose="020F0502020204030204" pitchFamily="34" charset="0"/>
                </a:rPr>
                <a:t>th</a:t>
              </a:r>
              <a:r>
                <a:rPr lang="en-US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 intron retention)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398813" y="2506376"/>
              <a:ext cx="237215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>
                <a:defRPr/>
              </a:pPr>
              <a:r>
                <a:rPr lang="en-US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SV3 </a:t>
              </a:r>
              <a:r>
                <a:rPr lang="en-US" sz="1000" dirty="0">
                  <a:solidFill>
                    <a:prstClr val="black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(4</a:t>
              </a:r>
              <a:r>
                <a:rPr lang="en-US" sz="1000" baseline="30000" dirty="0">
                  <a:solidFill>
                    <a:prstClr val="black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th</a:t>
              </a:r>
              <a:r>
                <a:rPr lang="en-US" sz="1000" dirty="0">
                  <a:solidFill>
                    <a:prstClr val="black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 intron retention)</a:t>
              </a:r>
            </a:p>
            <a:p>
              <a:pPr algn="ctr" defTabSz="457200">
                <a:defRPr/>
              </a:pPr>
              <a:endParaRPr lang="en-US" sz="10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141664" y="2677603"/>
              <a:ext cx="288830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>
                <a:defRPr/>
              </a:pPr>
              <a:r>
                <a:rPr lang="en-US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SV1 (5</a:t>
              </a:r>
              <a:r>
                <a:rPr lang="en-US" sz="1000" baseline="30000" dirty="0">
                  <a:latin typeface="Calibri" panose="020F0502020204030204" pitchFamily="34" charset="0"/>
                  <a:cs typeface="Calibri" panose="020F0502020204030204" pitchFamily="34" charset="0"/>
                </a:rPr>
                <a:t>th</a:t>
              </a:r>
              <a:r>
                <a:rPr lang="en-US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 intron retention)</a:t>
              </a:r>
            </a:p>
            <a:p>
              <a:pPr algn="ctr" defTabSz="457200">
                <a:defRPr/>
              </a:pPr>
              <a:endParaRPr lang="en-US" sz="10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472713" y="2842484"/>
              <a:ext cx="20250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>
                <a:defRPr/>
              </a:pPr>
              <a:r>
                <a:rPr lang="en-US" sz="1000" dirty="0">
                  <a:latin typeface="Calibri" panose="020F0502020204030204" pitchFamily="34" charset="0"/>
                  <a:cs typeface="Calibri" panose="020F0502020204030204" pitchFamily="34" charset="0"/>
                </a:rPr>
                <a:t>SV4 (without introns)</a:t>
              </a: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274417" y="841771"/>
            <a:ext cx="4776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  <a:endParaRPr lang="el-GR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275825" y="1978696"/>
            <a:ext cx="4776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  <a:endParaRPr lang="el-GR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4127753" y="1980169"/>
            <a:ext cx="4776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  <a:endParaRPr lang="el-GR" b="1" dirty="0"/>
          </a:p>
        </p:txBody>
      </p:sp>
      <p:cxnSp>
        <p:nvCxnSpPr>
          <p:cNvPr id="32" name="Straight Connector 31"/>
          <p:cNvCxnSpPr/>
          <p:nvPr/>
        </p:nvCxnSpPr>
        <p:spPr>
          <a:xfrm>
            <a:off x="4700089" y="3636133"/>
            <a:ext cx="1544951" cy="0"/>
          </a:xfrm>
          <a:prstGeom prst="line">
            <a:avLst/>
          </a:prstGeom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6145347" y="4617897"/>
            <a:ext cx="5566768" cy="0"/>
          </a:xfrm>
          <a:prstGeom prst="line">
            <a:avLst/>
          </a:prstGeom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7955871" y="1952990"/>
            <a:ext cx="5949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>
              <a:defRPr/>
            </a:pPr>
            <a:r>
              <a:rPr lang="en-US" sz="800" b="1" dirty="0">
                <a:latin typeface="Calibri" panose="020F0502020204030204" pitchFamily="34" charset="0"/>
                <a:cs typeface="Calibri" panose="020F0502020204030204" pitchFamily="34" charset="0"/>
              </a:rPr>
              <a:t>Intron 4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6074669" y="4418314"/>
            <a:ext cx="597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>
              <a:defRPr/>
            </a:pPr>
            <a:r>
              <a:rPr lang="en-US" sz="800" b="1" dirty="0">
                <a:latin typeface="Calibri" panose="020F0502020204030204" pitchFamily="34" charset="0"/>
                <a:cs typeface="Calibri" panose="020F0502020204030204" pitchFamily="34" charset="0"/>
              </a:rPr>
              <a:t>Intron 5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436063" y="7045540"/>
            <a:ext cx="4776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  <a:endParaRPr lang="el-GR" b="1" dirty="0"/>
          </a:p>
        </p:txBody>
      </p:sp>
      <p:grpSp>
        <p:nvGrpSpPr>
          <p:cNvPr id="42" name="Group 41"/>
          <p:cNvGrpSpPr/>
          <p:nvPr/>
        </p:nvGrpSpPr>
        <p:grpSpPr>
          <a:xfrm>
            <a:off x="1651361" y="7139623"/>
            <a:ext cx="1195755" cy="171545"/>
            <a:chOff x="1641836" y="7328765"/>
            <a:chExt cx="1195755" cy="171545"/>
          </a:xfrm>
        </p:grpSpPr>
        <p:cxnSp>
          <p:nvCxnSpPr>
            <p:cNvPr id="24" name="Straight Connector 23"/>
            <p:cNvCxnSpPr/>
            <p:nvPr/>
          </p:nvCxnSpPr>
          <p:spPr>
            <a:xfrm>
              <a:off x="1641836" y="7409823"/>
              <a:ext cx="1195755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>
              <a:off x="1641836" y="7328765"/>
              <a:ext cx="0" cy="167411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>
              <a:off x="2831602" y="7332899"/>
              <a:ext cx="0" cy="167411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3" name="Group 42"/>
          <p:cNvGrpSpPr/>
          <p:nvPr/>
        </p:nvGrpSpPr>
        <p:grpSpPr>
          <a:xfrm>
            <a:off x="2834596" y="7149148"/>
            <a:ext cx="1195755" cy="171545"/>
            <a:chOff x="1641836" y="7328765"/>
            <a:chExt cx="1195755" cy="171545"/>
          </a:xfrm>
        </p:grpSpPr>
        <p:cxnSp>
          <p:nvCxnSpPr>
            <p:cNvPr id="44" name="Straight Connector 43"/>
            <p:cNvCxnSpPr/>
            <p:nvPr/>
          </p:nvCxnSpPr>
          <p:spPr>
            <a:xfrm>
              <a:off x="1641836" y="7409823"/>
              <a:ext cx="1195755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>
              <a:off x="1641836" y="7328765"/>
              <a:ext cx="0" cy="167411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>
              <a:off x="2831602" y="7332899"/>
              <a:ext cx="0" cy="167411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7" name="Group 46"/>
          <p:cNvGrpSpPr/>
          <p:nvPr/>
        </p:nvGrpSpPr>
        <p:grpSpPr>
          <a:xfrm>
            <a:off x="4026367" y="7149148"/>
            <a:ext cx="1195755" cy="171545"/>
            <a:chOff x="1641836" y="7328765"/>
            <a:chExt cx="1195755" cy="171545"/>
          </a:xfrm>
        </p:grpSpPr>
        <p:cxnSp>
          <p:nvCxnSpPr>
            <p:cNvPr id="48" name="Straight Connector 47"/>
            <p:cNvCxnSpPr/>
            <p:nvPr/>
          </p:nvCxnSpPr>
          <p:spPr>
            <a:xfrm>
              <a:off x="1641836" y="7409823"/>
              <a:ext cx="1195755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/>
          </p:nvCxnSpPr>
          <p:spPr>
            <a:xfrm>
              <a:off x="1641836" y="7328765"/>
              <a:ext cx="0" cy="167411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50" name="Straight Connector 49"/>
            <p:cNvCxnSpPr/>
            <p:nvPr/>
          </p:nvCxnSpPr>
          <p:spPr>
            <a:xfrm>
              <a:off x="2831602" y="7332899"/>
              <a:ext cx="0" cy="167411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1" name="Group 50"/>
          <p:cNvGrpSpPr/>
          <p:nvPr/>
        </p:nvGrpSpPr>
        <p:grpSpPr>
          <a:xfrm>
            <a:off x="5216506" y="7143594"/>
            <a:ext cx="1195755" cy="171545"/>
            <a:chOff x="1641836" y="7328765"/>
            <a:chExt cx="1195755" cy="171545"/>
          </a:xfrm>
        </p:grpSpPr>
        <p:cxnSp>
          <p:nvCxnSpPr>
            <p:cNvPr id="52" name="Straight Connector 51"/>
            <p:cNvCxnSpPr/>
            <p:nvPr/>
          </p:nvCxnSpPr>
          <p:spPr>
            <a:xfrm>
              <a:off x="1641836" y="7409823"/>
              <a:ext cx="1195755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Straight Connector 52"/>
            <p:cNvCxnSpPr/>
            <p:nvPr/>
          </p:nvCxnSpPr>
          <p:spPr>
            <a:xfrm>
              <a:off x="1641836" y="7328765"/>
              <a:ext cx="0" cy="167411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/>
            <p:nvPr/>
          </p:nvCxnSpPr>
          <p:spPr>
            <a:xfrm>
              <a:off x="2831602" y="7332899"/>
              <a:ext cx="0" cy="167411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5" name="Group 54"/>
          <p:cNvGrpSpPr/>
          <p:nvPr/>
        </p:nvGrpSpPr>
        <p:grpSpPr>
          <a:xfrm>
            <a:off x="6406272" y="7149148"/>
            <a:ext cx="1195755" cy="171545"/>
            <a:chOff x="1641836" y="7328765"/>
            <a:chExt cx="1195755" cy="171545"/>
          </a:xfrm>
        </p:grpSpPr>
        <p:cxnSp>
          <p:nvCxnSpPr>
            <p:cNvPr id="56" name="Straight Connector 55"/>
            <p:cNvCxnSpPr/>
            <p:nvPr/>
          </p:nvCxnSpPr>
          <p:spPr>
            <a:xfrm>
              <a:off x="1641836" y="7409823"/>
              <a:ext cx="1195755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57" name="Straight Connector 56"/>
            <p:cNvCxnSpPr/>
            <p:nvPr/>
          </p:nvCxnSpPr>
          <p:spPr>
            <a:xfrm>
              <a:off x="1641836" y="7328765"/>
              <a:ext cx="0" cy="167411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58" name="Straight Connector 57"/>
            <p:cNvCxnSpPr/>
            <p:nvPr/>
          </p:nvCxnSpPr>
          <p:spPr>
            <a:xfrm>
              <a:off x="2831602" y="7332899"/>
              <a:ext cx="0" cy="167411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9" name="Group 58"/>
          <p:cNvGrpSpPr/>
          <p:nvPr/>
        </p:nvGrpSpPr>
        <p:grpSpPr>
          <a:xfrm>
            <a:off x="7588517" y="7148006"/>
            <a:ext cx="1195755" cy="171545"/>
            <a:chOff x="1641836" y="7328765"/>
            <a:chExt cx="1195755" cy="171545"/>
          </a:xfrm>
        </p:grpSpPr>
        <p:cxnSp>
          <p:nvCxnSpPr>
            <p:cNvPr id="60" name="Straight Connector 59"/>
            <p:cNvCxnSpPr/>
            <p:nvPr/>
          </p:nvCxnSpPr>
          <p:spPr>
            <a:xfrm>
              <a:off x="1641836" y="7409823"/>
              <a:ext cx="1195755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61" name="Straight Connector 60"/>
            <p:cNvCxnSpPr/>
            <p:nvPr/>
          </p:nvCxnSpPr>
          <p:spPr>
            <a:xfrm>
              <a:off x="1641836" y="7328765"/>
              <a:ext cx="0" cy="167411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62" name="Straight Connector 61"/>
            <p:cNvCxnSpPr/>
            <p:nvPr/>
          </p:nvCxnSpPr>
          <p:spPr>
            <a:xfrm>
              <a:off x="2831602" y="7332899"/>
              <a:ext cx="0" cy="167411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3" name="Group 62"/>
          <p:cNvGrpSpPr/>
          <p:nvPr/>
        </p:nvGrpSpPr>
        <p:grpSpPr>
          <a:xfrm>
            <a:off x="8786177" y="7152140"/>
            <a:ext cx="1195755" cy="171545"/>
            <a:chOff x="1641836" y="7328765"/>
            <a:chExt cx="1195755" cy="171545"/>
          </a:xfrm>
        </p:grpSpPr>
        <p:cxnSp>
          <p:nvCxnSpPr>
            <p:cNvPr id="64" name="Straight Connector 63"/>
            <p:cNvCxnSpPr/>
            <p:nvPr/>
          </p:nvCxnSpPr>
          <p:spPr>
            <a:xfrm>
              <a:off x="1641836" y="7409823"/>
              <a:ext cx="1195755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65" name="Straight Connector 64"/>
            <p:cNvCxnSpPr/>
            <p:nvPr/>
          </p:nvCxnSpPr>
          <p:spPr>
            <a:xfrm>
              <a:off x="1641836" y="7328765"/>
              <a:ext cx="0" cy="167411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66" name="Straight Connector 65"/>
            <p:cNvCxnSpPr/>
            <p:nvPr/>
          </p:nvCxnSpPr>
          <p:spPr>
            <a:xfrm>
              <a:off x="2831602" y="7332899"/>
              <a:ext cx="0" cy="167411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67" name="TextBox 66"/>
          <p:cNvSpPr txBox="1"/>
          <p:nvPr/>
        </p:nvSpPr>
        <p:spPr>
          <a:xfrm>
            <a:off x="1434816" y="6931234"/>
            <a:ext cx="4121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>
              <a:defRPr/>
            </a:pPr>
            <a:r>
              <a:rPr lang="en-US" sz="1000" dirty="0">
                <a:cs typeface="Calibri" panose="020F0502020204030204" pitchFamily="34" charset="0"/>
              </a:rPr>
              <a:t>0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2635059" y="6931235"/>
            <a:ext cx="4121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>
              <a:defRPr/>
            </a:pPr>
            <a:r>
              <a:rPr lang="en-US" sz="1000" dirty="0">
                <a:cs typeface="Calibri" panose="020F0502020204030204" pitchFamily="34" charset="0"/>
              </a:rPr>
              <a:t>200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3890139" y="6931234"/>
            <a:ext cx="4121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>
              <a:defRPr/>
            </a:pPr>
            <a:r>
              <a:rPr lang="en-US" sz="1000" dirty="0">
                <a:cs typeface="Calibri" panose="020F0502020204030204" pitchFamily="34" charset="0"/>
              </a:rPr>
              <a:t>400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5081741" y="6931235"/>
            <a:ext cx="4121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>
              <a:defRPr/>
            </a:pPr>
            <a:r>
              <a:rPr lang="en-US" sz="1000" dirty="0">
                <a:cs typeface="Calibri" panose="020F0502020204030204" pitchFamily="34" charset="0"/>
              </a:rPr>
              <a:t>600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6271507" y="6931234"/>
            <a:ext cx="4121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>
              <a:defRPr/>
            </a:pPr>
            <a:r>
              <a:rPr lang="en-US" sz="1000" dirty="0">
                <a:cs typeface="Calibri" panose="020F0502020204030204" pitchFamily="34" charset="0"/>
              </a:rPr>
              <a:t>800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7412902" y="6931235"/>
            <a:ext cx="4683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>
              <a:defRPr/>
            </a:pPr>
            <a:r>
              <a:rPr lang="en-US" sz="1000" dirty="0">
                <a:cs typeface="Calibri" panose="020F0502020204030204" pitchFamily="34" charset="0"/>
              </a:rPr>
              <a:t>1000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8542057" y="6931234"/>
            <a:ext cx="6028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>
              <a:defRPr/>
            </a:pPr>
            <a:r>
              <a:rPr lang="en-US" sz="1000" dirty="0">
                <a:cs typeface="Calibri" panose="020F0502020204030204" pitchFamily="34" charset="0"/>
              </a:rPr>
              <a:t>1200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9731934" y="6941567"/>
            <a:ext cx="6028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457200">
              <a:defRPr/>
            </a:pPr>
            <a:r>
              <a:rPr lang="en-US" sz="1000" dirty="0">
                <a:cs typeface="Calibri" panose="020F0502020204030204" pitchFamily="34" charset="0"/>
              </a:rPr>
              <a:t>1400</a:t>
            </a:r>
          </a:p>
        </p:txBody>
      </p:sp>
      <p:sp>
        <p:nvSpPr>
          <p:cNvPr id="78" name="Rectangle 77"/>
          <p:cNvSpPr/>
          <p:nvPr/>
        </p:nvSpPr>
        <p:spPr>
          <a:xfrm>
            <a:off x="1618756" y="7691113"/>
            <a:ext cx="7137288" cy="4762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79" name="Rectangle 78"/>
          <p:cNvSpPr/>
          <p:nvPr/>
        </p:nvSpPr>
        <p:spPr>
          <a:xfrm>
            <a:off x="1618756" y="8012344"/>
            <a:ext cx="6587764" cy="5158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80" name="Rectangle 79"/>
          <p:cNvSpPr/>
          <p:nvPr/>
        </p:nvSpPr>
        <p:spPr>
          <a:xfrm>
            <a:off x="1613042" y="8388012"/>
            <a:ext cx="6587764" cy="6329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81" name="Rectangle 80"/>
          <p:cNvSpPr/>
          <p:nvPr/>
        </p:nvSpPr>
        <p:spPr>
          <a:xfrm>
            <a:off x="1618756" y="8739165"/>
            <a:ext cx="7630116" cy="6280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82" name="Rectangle 81"/>
          <p:cNvSpPr/>
          <p:nvPr/>
        </p:nvSpPr>
        <p:spPr>
          <a:xfrm>
            <a:off x="1680797" y="7632443"/>
            <a:ext cx="882459" cy="148355"/>
          </a:xfrm>
          <a:prstGeom prst="rect">
            <a:avLst/>
          </a:prstGeom>
          <a:solidFill>
            <a:schemeClr val="accent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83" name="Rectangle 82"/>
          <p:cNvSpPr/>
          <p:nvPr/>
        </p:nvSpPr>
        <p:spPr>
          <a:xfrm>
            <a:off x="1680797" y="7958023"/>
            <a:ext cx="882459" cy="148355"/>
          </a:xfrm>
          <a:prstGeom prst="rect">
            <a:avLst/>
          </a:prstGeom>
          <a:solidFill>
            <a:schemeClr val="accent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84" name="Rectangle 83"/>
          <p:cNvSpPr/>
          <p:nvPr/>
        </p:nvSpPr>
        <p:spPr>
          <a:xfrm>
            <a:off x="1680797" y="8348199"/>
            <a:ext cx="882459" cy="148355"/>
          </a:xfrm>
          <a:prstGeom prst="rect">
            <a:avLst/>
          </a:prstGeom>
          <a:solidFill>
            <a:schemeClr val="accent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85" name="Rectangle 84"/>
          <p:cNvSpPr/>
          <p:nvPr/>
        </p:nvSpPr>
        <p:spPr>
          <a:xfrm>
            <a:off x="1688358" y="8693056"/>
            <a:ext cx="882459" cy="148355"/>
          </a:xfrm>
          <a:prstGeom prst="rect">
            <a:avLst/>
          </a:prstGeom>
          <a:solidFill>
            <a:schemeClr val="accent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86" name="Rectangle 85"/>
          <p:cNvSpPr/>
          <p:nvPr/>
        </p:nvSpPr>
        <p:spPr>
          <a:xfrm>
            <a:off x="3014590" y="7632443"/>
            <a:ext cx="1402885" cy="148355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87" name="Rectangle 86"/>
          <p:cNvSpPr/>
          <p:nvPr/>
        </p:nvSpPr>
        <p:spPr>
          <a:xfrm>
            <a:off x="3014590" y="7958023"/>
            <a:ext cx="1402885" cy="148355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88" name="Rectangle 87"/>
          <p:cNvSpPr/>
          <p:nvPr/>
        </p:nvSpPr>
        <p:spPr>
          <a:xfrm>
            <a:off x="3014590" y="8348199"/>
            <a:ext cx="1402885" cy="148355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89" name="Rectangle 88"/>
          <p:cNvSpPr/>
          <p:nvPr/>
        </p:nvSpPr>
        <p:spPr>
          <a:xfrm>
            <a:off x="3022151" y="8693056"/>
            <a:ext cx="1402885" cy="148355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90" name="Rectangle 89"/>
          <p:cNvSpPr/>
          <p:nvPr/>
        </p:nvSpPr>
        <p:spPr>
          <a:xfrm>
            <a:off x="7937914" y="7639796"/>
            <a:ext cx="242890" cy="151262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91" name="Rectangle 90"/>
          <p:cNvSpPr/>
          <p:nvPr/>
        </p:nvSpPr>
        <p:spPr>
          <a:xfrm>
            <a:off x="7940830" y="7965376"/>
            <a:ext cx="239973" cy="141002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92" name="Rectangle 91"/>
          <p:cNvSpPr/>
          <p:nvPr/>
        </p:nvSpPr>
        <p:spPr>
          <a:xfrm>
            <a:off x="7940830" y="8347932"/>
            <a:ext cx="239973" cy="141002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93" name="Rectangle 92"/>
          <p:cNvSpPr/>
          <p:nvPr/>
        </p:nvSpPr>
        <p:spPr>
          <a:xfrm>
            <a:off x="7948391" y="8700409"/>
            <a:ext cx="239973" cy="141002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94" name="Rectangle 93"/>
          <p:cNvSpPr/>
          <p:nvPr/>
        </p:nvSpPr>
        <p:spPr>
          <a:xfrm>
            <a:off x="8620526" y="8707116"/>
            <a:ext cx="341326" cy="131438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102" name="TextBox 101"/>
          <p:cNvSpPr txBox="1"/>
          <p:nvPr/>
        </p:nvSpPr>
        <p:spPr>
          <a:xfrm>
            <a:off x="10747377" y="7919657"/>
            <a:ext cx="10604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NB-ARC-domain</a:t>
            </a:r>
            <a:endParaRPr lang="el-GR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10741758" y="8204995"/>
            <a:ext cx="10660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WRKY  domain</a:t>
            </a:r>
            <a:endParaRPr lang="el-GR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4" name="Rectangle 103"/>
          <p:cNvSpPr/>
          <p:nvPr/>
        </p:nvSpPr>
        <p:spPr>
          <a:xfrm>
            <a:off x="10546354" y="7658244"/>
            <a:ext cx="201024" cy="163924"/>
          </a:xfrm>
          <a:prstGeom prst="rect">
            <a:avLst/>
          </a:prstGeom>
          <a:solidFill>
            <a:schemeClr val="accent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107" name="Rectangle 106"/>
          <p:cNvSpPr/>
          <p:nvPr/>
        </p:nvSpPr>
        <p:spPr>
          <a:xfrm>
            <a:off x="10546354" y="7965609"/>
            <a:ext cx="201024" cy="163924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108" name="Rectangle 107"/>
          <p:cNvSpPr/>
          <p:nvPr/>
        </p:nvSpPr>
        <p:spPr>
          <a:xfrm>
            <a:off x="10546354" y="8240827"/>
            <a:ext cx="201024" cy="163924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109" name="TextBox 108"/>
          <p:cNvSpPr txBox="1"/>
          <p:nvPr/>
        </p:nvSpPr>
        <p:spPr>
          <a:xfrm>
            <a:off x="864523" y="7591814"/>
            <a:ext cx="8466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Isoform 1</a:t>
            </a:r>
            <a:endParaRPr lang="el-GR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859410" y="7909089"/>
            <a:ext cx="8466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Isoform 2</a:t>
            </a:r>
            <a:endParaRPr lang="el-GR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860045" y="8290572"/>
            <a:ext cx="8466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Isoform 3</a:t>
            </a:r>
            <a:endParaRPr lang="el-GR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855708" y="8631658"/>
            <a:ext cx="8466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Isoform 4</a:t>
            </a:r>
            <a:endParaRPr lang="el-GR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98" name="Straight Connector 97"/>
          <p:cNvCxnSpPr/>
          <p:nvPr/>
        </p:nvCxnSpPr>
        <p:spPr>
          <a:xfrm flipV="1">
            <a:off x="7820774" y="2160858"/>
            <a:ext cx="3897691" cy="12783"/>
          </a:xfrm>
          <a:prstGeom prst="line">
            <a:avLst/>
          </a:prstGeom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00" name="Straight Connector 99"/>
          <p:cNvCxnSpPr/>
          <p:nvPr/>
        </p:nvCxnSpPr>
        <p:spPr>
          <a:xfrm>
            <a:off x="4712825" y="3153389"/>
            <a:ext cx="6992940" cy="0"/>
          </a:xfrm>
          <a:prstGeom prst="line">
            <a:avLst/>
          </a:prstGeom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05" name="Straight Connector 104"/>
          <p:cNvCxnSpPr/>
          <p:nvPr/>
        </p:nvCxnSpPr>
        <p:spPr>
          <a:xfrm>
            <a:off x="4725525" y="2670332"/>
            <a:ext cx="6992940" cy="0"/>
          </a:xfrm>
          <a:prstGeom prst="line">
            <a:avLst/>
          </a:prstGeom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06" name="Straight Connector 105"/>
          <p:cNvCxnSpPr/>
          <p:nvPr/>
        </p:nvCxnSpPr>
        <p:spPr>
          <a:xfrm>
            <a:off x="4709100" y="5094403"/>
            <a:ext cx="633965" cy="0"/>
          </a:xfrm>
          <a:prstGeom prst="line">
            <a:avLst/>
          </a:prstGeom>
          <a:ln w="12700" cap="flat" cmpd="sng" algn="ctr">
            <a:solidFill>
              <a:schemeClr val="dk1"/>
            </a:solidFill>
            <a:prstDash val="solid"/>
            <a:round/>
            <a:headEnd type="none" w="med" len="med"/>
            <a:tailEnd type="triangl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97" name="Rectangle 96"/>
          <p:cNvSpPr/>
          <p:nvPr/>
        </p:nvSpPr>
        <p:spPr>
          <a:xfrm>
            <a:off x="8998930" y="4616792"/>
            <a:ext cx="146685" cy="81058"/>
          </a:xfrm>
          <a:prstGeom prst="rect">
            <a:avLst/>
          </a:prstGeom>
          <a:noFill/>
          <a:ln w="12700">
            <a:solidFill>
              <a:srgbClr val="FF0000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113" name="Rectangle 112"/>
          <p:cNvSpPr/>
          <p:nvPr/>
        </p:nvSpPr>
        <p:spPr>
          <a:xfrm>
            <a:off x="9424166" y="2286335"/>
            <a:ext cx="146685" cy="120015"/>
          </a:xfrm>
          <a:prstGeom prst="rect">
            <a:avLst/>
          </a:prstGeom>
          <a:noFill/>
          <a:ln w="12700">
            <a:solidFill>
              <a:srgbClr val="FF0000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115" name="Rectangle 114"/>
          <p:cNvSpPr/>
          <p:nvPr/>
        </p:nvSpPr>
        <p:spPr>
          <a:xfrm>
            <a:off x="7400327" y="6090844"/>
            <a:ext cx="133350" cy="81058"/>
          </a:xfrm>
          <a:prstGeom prst="rect">
            <a:avLst/>
          </a:prstGeom>
          <a:noFill/>
          <a:ln w="9525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sp>
        <p:nvSpPr>
          <p:cNvPr id="118" name="TextBox 117"/>
          <p:cNvSpPr txBox="1"/>
          <p:nvPr/>
        </p:nvSpPr>
        <p:spPr>
          <a:xfrm>
            <a:off x="10741758" y="7626971"/>
            <a:ext cx="8466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CC-domain</a:t>
            </a:r>
            <a:endParaRPr lang="el-GR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1" name="Rectangle 100"/>
          <p:cNvSpPr/>
          <p:nvPr/>
        </p:nvSpPr>
        <p:spPr>
          <a:xfrm>
            <a:off x="8999871" y="4791666"/>
            <a:ext cx="146685" cy="81058"/>
          </a:xfrm>
          <a:prstGeom prst="rect">
            <a:avLst/>
          </a:prstGeom>
          <a:noFill/>
          <a:ln w="12700">
            <a:solidFill>
              <a:srgbClr val="FF0000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7555244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3</TotalTime>
  <Words>62</Words>
  <Application>Microsoft Office PowerPoint</Application>
  <PresentationFormat>Custom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Madhav Nepal</cp:lastModifiedBy>
  <cp:revision>46</cp:revision>
  <dcterms:created xsi:type="dcterms:W3CDTF">2019-11-19T08:18:30Z</dcterms:created>
  <dcterms:modified xsi:type="dcterms:W3CDTF">2020-04-18T16:51:35Z</dcterms:modified>
</cp:coreProperties>
</file>